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2400" y="3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1CF7-AA81-4171-AEFB-815CCD43CC9F}" type="datetimeFigureOut">
              <a:rPr lang="de-DE" smtClean="0"/>
              <a:t>23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83023-5E15-4666-B74C-E0D3C13082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4831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1CF7-AA81-4171-AEFB-815CCD43CC9F}" type="datetimeFigureOut">
              <a:rPr lang="de-DE" smtClean="0"/>
              <a:t>23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83023-5E15-4666-B74C-E0D3C13082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3102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1CF7-AA81-4171-AEFB-815CCD43CC9F}" type="datetimeFigureOut">
              <a:rPr lang="de-DE" smtClean="0"/>
              <a:t>23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83023-5E15-4666-B74C-E0D3C13082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4159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1CF7-AA81-4171-AEFB-815CCD43CC9F}" type="datetimeFigureOut">
              <a:rPr lang="de-DE" smtClean="0"/>
              <a:t>23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83023-5E15-4666-B74C-E0D3C13082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916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1CF7-AA81-4171-AEFB-815CCD43CC9F}" type="datetimeFigureOut">
              <a:rPr lang="de-DE" smtClean="0"/>
              <a:t>23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83023-5E15-4666-B74C-E0D3C13082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8204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1CF7-AA81-4171-AEFB-815CCD43CC9F}" type="datetimeFigureOut">
              <a:rPr lang="de-DE" smtClean="0"/>
              <a:t>23.08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83023-5E15-4666-B74C-E0D3C13082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4777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1CF7-AA81-4171-AEFB-815CCD43CC9F}" type="datetimeFigureOut">
              <a:rPr lang="de-DE" smtClean="0"/>
              <a:t>23.08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83023-5E15-4666-B74C-E0D3C13082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6046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1CF7-AA81-4171-AEFB-815CCD43CC9F}" type="datetimeFigureOut">
              <a:rPr lang="de-DE" smtClean="0"/>
              <a:t>23.08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83023-5E15-4666-B74C-E0D3C13082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00383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1CF7-AA81-4171-AEFB-815CCD43CC9F}" type="datetimeFigureOut">
              <a:rPr lang="de-DE" smtClean="0"/>
              <a:t>23.08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83023-5E15-4666-B74C-E0D3C13082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8473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1CF7-AA81-4171-AEFB-815CCD43CC9F}" type="datetimeFigureOut">
              <a:rPr lang="de-DE" smtClean="0"/>
              <a:t>23.08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83023-5E15-4666-B74C-E0D3C13082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9802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1CF7-AA81-4171-AEFB-815CCD43CC9F}" type="datetimeFigureOut">
              <a:rPr lang="de-DE" smtClean="0"/>
              <a:t>23.08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83023-5E15-4666-B74C-E0D3C13082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0140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01CF7-AA81-4171-AEFB-815CCD43CC9F}" type="datetimeFigureOut">
              <a:rPr lang="de-DE" smtClean="0"/>
              <a:t>23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B83023-5E15-4666-B74C-E0D3C13082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54371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en 4"/>
          <p:cNvGrpSpPr/>
          <p:nvPr/>
        </p:nvGrpSpPr>
        <p:grpSpPr>
          <a:xfrm>
            <a:off x="3429320" y="755576"/>
            <a:ext cx="2880000" cy="3060000"/>
            <a:chOff x="395536" y="1593136"/>
            <a:chExt cx="2880000" cy="3060000"/>
          </a:xfrm>
        </p:grpSpPr>
        <p:pic>
          <p:nvPicPr>
            <p:cNvPr id="6" name="Picture 2"/>
            <p:cNvPicPr preferRelativeResize="0">
              <a:picLocks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5536" y="1593136"/>
              <a:ext cx="2880000" cy="306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Textfeld 6"/>
            <p:cNvSpPr txBox="1"/>
            <p:nvPr/>
          </p:nvSpPr>
          <p:spPr>
            <a:xfrm>
              <a:off x="2411760" y="2673256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=-0.20</a:t>
              </a:r>
            </a:p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39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uppieren 7"/>
          <p:cNvGrpSpPr/>
          <p:nvPr/>
        </p:nvGrpSpPr>
        <p:grpSpPr>
          <a:xfrm>
            <a:off x="476672" y="753584"/>
            <a:ext cx="2880000" cy="3060000"/>
            <a:chOff x="2915816" y="1484784"/>
            <a:chExt cx="2880000" cy="3060000"/>
          </a:xfrm>
        </p:grpSpPr>
        <p:pic>
          <p:nvPicPr>
            <p:cNvPr id="9" name="Picture 2"/>
            <p:cNvPicPr preferRelativeResize="0"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15816" y="1484784"/>
              <a:ext cx="2880000" cy="306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Textfeld 9"/>
            <p:cNvSpPr txBox="1"/>
            <p:nvPr/>
          </p:nvSpPr>
          <p:spPr>
            <a:xfrm>
              <a:off x="4932040" y="2461538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=0.28</a:t>
              </a:r>
            </a:p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2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Gruppieren 10"/>
          <p:cNvGrpSpPr/>
          <p:nvPr/>
        </p:nvGrpSpPr>
        <p:grpSpPr>
          <a:xfrm>
            <a:off x="478995" y="4211960"/>
            <a:ext cx="2880000" cy="3060000"/>
            <a:chOff x="3213611" y="1593136"/>
            <a:chExt cx="2880000" cy="3060000"/>
          </a:xfrm>
        </p:grpSpPr>
        <p:pic>
          <p:nvPicPr>
            <p:cNvPr id="12" name="Picture 3"/>
            <p:cNvPicPr preferRelativeResize="0"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13611" y="1593136"/>
              <a:ext cx="2880000" cy="306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" name="Textfeld 12"/>
            <p:cNvSpPr txBox="1"/>
            <p:nvPr/>
          </p:nvSpPr>
          <p:spPr>
            <a:xfrm>
              <a:off x="5220072" y="2267580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=0.36</a:t>
              </a:r>
            </a:p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11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Gruppieren 13"/>
          <p:cNvGrpSpPr/>
          <p:nvPr/>
        </p:nvGrpSpPr>
        <p:grpSpPr>
          <a:xfrm>
            <a:off x="3429320" y="4211163"/>
            <a:ext cx="2880000" cy="3060000"/>
            <a:chOff x="6012480" y="1593136"/>
            <a:chExt cx="2880000" cy="3060000"/>
          </a:xfrm>
        </p:grpSpPr>
        <p:pic>
          <p:nvPicPr>
            <p:cNvPr id="15" name="Picture 4"/>
            <p:cNvPicPr preferRelativeResize="0">
              <a:picLocks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12480" y="1593136"/>
              <a:ext cx="2880000" cy="306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" name="Textfeld 15"/>
            <p:cNvSpPr txBox="1"/>
            <p:nvPr/>
          </p:nvSpPr>
          <p:spPr>
            <a:xfrm>
              <a:off x="8100392" y="2234635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=0.10 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67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Textfeld 19"/>
          <p:cNvSpPr txBox="1"/>
          <p:nvPr/>
        </p:nvSpPr>
        <p:spPr>
          <a:xfrm>
            <a:off x="260648" y="830167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21" name="Textfeld 20"/>
          <p:cNvSpPr txBox="1"/>
          <p:nvPr/>
        </p:nvSpPr>
        <p:spPr>
          <a:xfrm>
            <a:off x="3284984" y="82758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22" name="Textfeld 21"/>
          <p:cNvSpPr txBox="1"/>
          <p:nvPr/>
        </p:nvSpPr>
        <p:spPr>
          <a:xfrm>
            <a:off x="260648" y="4274676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C</a:t>
            </a:r>
            <a:endParaRPr lang="de-DE" dirty="0"/>
          </a:p>
        </p:txBody>
      </p:sp>
      <p:sp>
        <p:nvSpPr>
          <p:cNvPr id="23" name="Textfeld 22"/>
          <p:cNvSpPr txBox="1"/>
          <p:nvPr/>
        </p:nvSpPr>
        <p:spPr>
          <a:xfrm>
            <a:off x="3284984" y="4250926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D</a:t>
            </a:r>
            <a:endParaRPr lang="de-DE" dirty="0"/>
          </a:p>
        </p:txBody>
      </p:sp>
      <p:sp>
        <p:nvSpPr>
          <p:cNvPr id="4" name="Rechteck 3"/>
          <p:cNvSpPr/>
          <p:nvPr/>
        </p:nvSpPr>
        <p:spPr>
          <a:xfrm>
            <a:off x="476672" y="7532538"/>
            <a:ext cx="604867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rrelation analysis of age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g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numbers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IRT1 mRNA,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iRNA-124 expression, and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iR-155 expression.  Analyses revealed no significant correlations. Black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ts: Neuropathic pain patients, white dots: Healthy volunteers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340766" y="166456"/>
            <a:ext cx="42461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ents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15143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en 4"/>
          <p:cNvGrpSpPr/>
          <p:nvPr/>
        </p:nvGrpSpPr>
        <p:grpSpPr>
          <a:xfrm>
            <a:off x="332656" y="1892156"/>
            <a:ext cx="6340559" cy="2823860"/>
            <a:chOff x="404664" y="1892156"/>
            <a:chExt cx="6340559" cy="2823860"/>
          </a:xfrm>
        </p:grpSpPr>
        <p:pic>
          <p:nvPicPr>
            <p:cNvPr id="1032" name="Picture 8" descr="G:\Labor\Jens\CTLA4.JPG"/>
            <p:cNvPicPr>
              <a:picLocks noChangeAspect="1" noChangeArrowheads="1"/>
            </p:cNvPicPr>
            <p:nvPr/>
          </p:nvPicPr>
          <p:blipFill>
            <a:blip r:embed="rId2" cstate="print"/>
            <a:srcRect l="22411" t="19544" r="31601" b="14718"/>
            <a:stretch>
              <a:fillRect/>
            </a:stretch>
          </p:blipFill>
          <p:spPr bwMode="auto">
            <a:xfrm>
              <a:off x="2564904" y="2036172"/>
              <a:ext cx="2160240" cy="2664296"/>
            </a:xfrm>
            <a:prstGeom prst="rect">
              <a:avLst/>
            </a:prstGeom>
            <a:noFill/>
          </p:spPr>
        </p:pic>
        <p:pic>
          <p:nvPicPr>
            <p:cNvPr id="1034" name="Picture 10" descr="G:\Labor\Jens\EOS.JPG"/>
            <p:cNvPicPr>
              <a:picLocks noChangeAspect="1" noChangeArrowheads="1"/>
            </p:cNvPicPr>
            <p:nvPr/>
          </p:nvPicPr>
          <p:blipFill>
            <a:blip r:embed="rId3" cstate="print"/>
            <a:srcRect l="22227" t="13403" r="31785" b="11923"/>
            <a:stretch>
              <a:fillRect/>
            </a:stretch>
          </p:blipFill>
          <p:spPr bwMode="auto">
            <a:xfrm>
              <a:off x="404664" y="1892156"/>
              <a:ext cx="2160240" cy="2808312"/>
            </a:xfrm>
            <a:prstGeom prst="rect">
              <a:avLst/>
            </a:prstGeom>
            <a:noFill/>
          </p:spPr>
        </p:pic>
        <p:pic>
          <p:nvPicPr>
            <p:cNvPr id="1036" name="Picture 12" descr="G:\Labor\Jens\IL2RA.JPG"/>
            <p:cNvPicPr>
              <a:picLocks noChangeAspect="1" noChangeArrowheads="1"/>
            </p:cNvPicPr>
            <p:nvPr/>
          </p:nvPicPr>
          <p:blipFill>
            <a:blip r:embed="rId4" cstate="print"/>
            <a:srcRect l="28359" t="10531" r="25653" b="18625"/>
            <a:stretch>
              <a:fillRect/>
            </a:stretch>
          </p:blipFill>
          <p:spPr bwMode="auto">
            <a:xfrm>
              <a:off x="4584983" y="2051720"/>
              <a:ext cx="2160240" cy="2664296"/>
            </a:xfrm>
            <a:prstGeom prst="rect">
              <a:avLst/>
            </a:prstGeom>
            <a:noFill/>
          </p:spPr>
        </p:pic>
      </p:grpSp>
      <p:sp>
        <p:nvSpPr>
          <p:cNvPr id="2" name="Textfeld 1"/>
          <p:cNvSpPr txBox="1"/>
          <p:nvPr/>
        </p:nvSpPr>
        <p:spPr>
          <a:xfrm>
            <a:off x="586847" y="5148064"/>
            <a:ext cx="568863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uman CD4+ T cells were transfected with either pre-miR-124a, pre-miR-155 or scrambled control, followed by culturing under </a:t>
            </a:r>
            <a:r>
              <a:rPr lang="en-US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eg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kewing conditions for four days. Relative </a:t>
            </a:r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RNA 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</a:t>
            </a:r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2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eg</a:t>
            </a:r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gnature molecules </a:t>
            </a:r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OS, CTLA4, 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IL2RA </a:t>
            </a:r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as 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tected by </a:t>
            </a:r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*p&lt;0,05, **p&lt;0,01, n=5.</a:t>
            </a:r>
            <a:endParaRPr lang="de-DE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59817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457864" y="6516216"/>
            <a:ext cx="604867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rrelation analysis of either miR-124a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r miR-155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Foxp3 mRNA expression. Black dots: Neuropathic pain patients, white dots: Healthy volunteers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Picture 10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0688" y="2520112"/>
            <a:ext cx="2880000" cy="30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Textfeld 19"/>
          <p:cNvSpPr txBox="1"/>
          <p:nvPr/>
        </p:nvSpPr>
        <p:spPr>
          <a:xfrm>
            <a:off x="404664" y="255954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A</a:t>
            </a:r>
            <a:endParaRPr lang="de-DE" dirty="0"/>
          </a:p>
        </p:txBody>
      </p:sp>
      <p:pic>
        <p:nvPicPr>
          <p:cNvPr id="25" name="Picture 11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3016" y="2520112"/>
            <a:ext cx="2880000" cy="30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Textfeld 20"/>
          <p:cNvSpPr txBox="1"/>
          <p:nvPr/>
        </p:nvSpPr>
        <p:spPr>
          <a:xfrm>
            <a:off x="3429000" y="2557117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27" name="Textfeld 26"/>
          <p:cNvSpPr txBox="1"/>
          <p:nvPr/>
        </p:nvSpPr>
        <p:spPr>
          <a:xfrm>
            <a:off x="2564904" y="3203848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=0.63</a:t>
            </a:r>
          </a:p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=0.003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5445224" y="3205353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=0.52</a:t>
            </a:r>
          </a:p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=0.0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42770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3</Words>
  <Application>Microsoft Office PowerPoint</Application>
  <PresentationFormat>Bildschirmpräsentation (4:3)</PresentationFormat>
  <Paragraphs>21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Larissa</vt:lpstr>
      <vt:lpstr>PowerPoint-Präsentation</vt:lpstr>
      <vt:lpstr>PowerPoint-Präsentation</vt:lpstr>
      <vt:lpstr>PowerPoint-Präsentation</vt:lpstr>
    </vt:vector>
  </TitlesOfParts>
  <Company>Klinikum der Universitaet Muench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heyn</dc:creator>
  <cp:lastModifiedBy>skreth</cp:lastModifiedBy>
  <cp:revision>13</cp:revision>
  <dcterms:created xsi:type="dcterms:W3CDTF">2016-07-28T10:54:15Z</dcterms:created>
  <dcterms:modified xsi:type="dcterms:W3CDTF">2016-08-23T06:51:19Z</dcterms:modified>
</cp:coreProperties>
</file>